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sldImg"/>
          </p:nvPr>
        </p:nvSpPr>
        <p:spPr>
          <a:xfrm>
            <a:off x="1371600" y="763200"/>
            <a:ext cx="5027760" cy="3770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>
              <a:lnSpc>
                <a:spcPct val="10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777960" y="4776840"/>
            <a:ext cx="62164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hdr"/>
          </p:nvPr>
        </p:nvSpPr>
        <p:spPr>
          <a:xfrm>
            <a:off x="0" y="-360"/>
            <a:ext cx="3371760" cy="50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head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dt" idx="3"/>
          </p:nvPr>
        </p:nvSpPr>
        <p:spPr>
          <a:xfrm>
            <a:off x="4398480" y="-360"/>
            <a:ext cx="3372120" cy="50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4"/>
          </p:nvPr>
        </p:nvSpPr>
        <p:spPr>
          <a:xfrm>
            <a:off x="0" y="9555120"/>
            <a:ext cx="3371760" cy="50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5"/>
          </p:nvPr>
        </p:nvSpPr>
        <p:spPr>
          <a:xfrm>
            <a:off x="4398480" y="9555120"/>
            <a:ext cx="3372120" cy="50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2BF9E67D-FCFB-4344-BB95-E145F21F2C2C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"/>
          <p:cNvSpPr/>
          <p:nvPr/>
        </p:nvSpPr>
        <p:spPr>
          <a:xfrm>
            <a:off x="0" y="0"/>
            <a:ext cx="1440" cy="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-44280" bIns="-90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347BCC9-CC83-4CC8-AE90-032F66FD7DD4}" type="slidenum">
              <a:rPr b="0" lang="en-US" sz="1800" spc="-1" strike="noStrike">
                <a:solidFill>
                  <a:srgbClr val="000000"/>
                </a:solidFill>
                <a:latin typeface="+mn-lt"/>
                <a:ea typeface="+mn-ea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61" name="PlaceHolder 2"/>
          <p:cNvSpPr>
            <a:spLocks noGrp="1"/>
          </p:cNvSpPr>
          <p:nvPr>
            <p:ph type="body"/>
          </p:nvPr>
        </p:nvSpPr>
        <p:spPr>
          <a:xfrm>
            <a:off x="914400" y="4338720"/>
            <a:ext cx="5029200" cy="4124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  <a:ea typeface="Arial Unicode MS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F2C66A0-3AED-4A44-A4F5-1B4FEDC6732B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037EFD6-7EEF-44FC-880F-586BE0B17A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0FDB920-6D37-4291-8DD4-C35A068B07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378F165-467A-4A00-AC43-70EBE805B10B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92FEF5C-7551-41D1-893A-A34DB17EBB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C5DC0A0-1263-44DB-8009-052040B2C0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74F6428-BD5E-4BA3-8DEC-902F125E38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A4E2F53-A12A-451F-9F6E-202811C1DD0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35BA49E-9DFB-4703-8AC5-43D6D3D0AE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C4AFED2-9527-4109-9441-4A7338EEBB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5FCE4AC-E5C2-449E-86C9-8203BF8E74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A72D7BA-2E55-4AD9-9246-881ACFF87F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8b8b8b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8b8b8b"/>
                </a:solidFill>
                <a:latin typeface="Calibri"/>
              </a:rPr>
              <a:t>7/10/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8b8b8b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33FFECD6-1341-4E38-AF5E-DB892665AFF0}" type="slidenum">
              <a:rPr b="0" lang="en-US" sz="1800" spc="-1" strike="noStrike">
                <a:solidFill>
                  <a:srgbClr val="8b8b8b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2832120" y="2597040"/>
            <a:ext cx="3390840" cy="692280"/>
          </a:xfrm>
          <a:prstGeom prst="rect">
            <a:avLst/>
          </a:prstGeom>
          <a:solidFill>
            <a:srgbClr val="ffffff"/>
          </a:solidFill>
          <a:ln w="9360">
            <a:solidFill>
              <a:srgbClr val="bfbfb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320840" y="5656320"/>
            <a:ext cx="2816280" cy="1440"/>
          </a:xfrm>
          <a:prstGeom prst="line">
            <a:avLst/>
          </a:prstGeom>
          <a:ln w="12060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flipH="1">
            <a:off x="3993840" y="5219640"/>
            <a:ext cx="98280" cy="38592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405800" y="1430280"/>
            <a:ext cx="74448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SfiIM(1-8)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85720" y="1440000"/>
            <a:ext cx="39852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d5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830880" y="1757520"/>
            <a:ext cx="73836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SfiIM(1-8)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211120" y="1757520"/>
            <a:ext cx="45936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ev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471680" y="1924200"/>
            <a:ext cx="806400" cy="96840"/>
          </a:xfrm>
          <a:prstGeom prst="rect">
            <a:avLst/>
          </a:prstGeom>
          <a:solidFill>
            <a:srgbClr val="ff6600"/>
          </a:solidFill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398600" y="1873080"/>
            <a:ext cx="168120" cy="1800"/>
          </a:xfrm>
          <a:prstGeom prst="line">
            <a:avLst/>
          </a:prstGeom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88960" y="797040"/>
            <a:ext cx="34812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773440" y="792000"/>
            <a:ext cx="34812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711680" y="1873080"/>
            <a:ext cx="1014480" cy="59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fi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 diges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 gel purif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 lig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5022720" y="2773440"/>
            <a:ext cx="8877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igation mi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925720" y="1943280"/>
            <a:ext cx="390600" cy="1440"/>
          </a:xfrm>
          <a:prstGeom prst="line">
            <a:avLst/>
          </a:prstGeom>
          <a:ln w="10152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4241520" y="1765440"/>
            <a:ext cx="547560" cy="699840"/>
          </a:xfrm>
          <a:prstGeom prst="line">
            <a:avLst/>
          </a:prstGeom>
          <a:ln w="255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422360" y="2297160"/>
            <a:ext cx="1800" cy="360360"/>
          </a:xfrm>
          <a:prstGeom prst="line">
            <a:avLst/>
          </a:prstGeom>
          <a:ln w="255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H="1">
            <a:off x="3706560" y="1508040"/>
            <a:ext cx="672840" cy="358920"/>
          </a:xfrm>
          <a:prstGeom prst="line">
            <a:avLst/>
          </a:prstGeom>
          <a:ln w="255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206600" y="6318360"/>
            <a:ext cx="224100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=   AD∆/constructs(1,2,4-18)-CD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441440" y="2327400"/>
            <a:ext cx="736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xoSA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441440" y="3467160"/>
            <a:ext cx="89208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usion PC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983040" y="3308400"/>
            <a:ext cx="2165400" cy="59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CR amplify with pd5f/Rev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nly the ‘right’ fragment can be amplified from the ligation mix!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" name=""/>
          <p:cNvGrpSpPr/>
          <p:nvPr/>
        </p:nvGrpSpPr>
        <p:grpSpPr>
          <a:xfrm>
            <a:off x="3895200" y="1557360"/>
            <a:ext cx="275040" cy="276120"/>
            <a:chOff x="3895200" y="1557360"/>
            <a:chExt cx="275040" cy="276120"/>
          </a:xfrm>
        </p:grpSpPr>
        <p:sp>
          <p:nvSpPr>
            <p:cNvPr id="70" name=""/>
            <p:cNvSpPr/>
            <p:nvPr/>
          </p:nvSpPr>
          <p:spPr>
            <a:xfrm flipH="1">
              <a:off x="3895200" y="1557360"/>
              <a:ext cx="266760" cy="272880"/>
            </a:xfrm>
            <a:prstGeom prst="line">
              <a:avLst/>
            </a:prstGeom>
            <a:ln w="38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906720" y="1560600"/>
              <a:ext cx="263520" cy="272880"/>
            </a:xfrm>
            <a:prstGeom prst="line">
              <a:avLst/>
            </a:prstGeom>
            <a:ln w="38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"/>
          <p:cNvSpPr/>
          <p:nvPr/>
        </p:nvSpPr>
        <p:spPr>
          <a:xfrm>
            <a:off x="588960" y="4395960"/>
            <a:ext cx="34812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H="1">
            <a:off x="2739600" y="814320"/>
            <a:ext cx="4680" cy="3564000"/>
          </a:xfrm>
          <a:prstGeom prst="line">
            <a:avLst/>
          </a:prstGeom>
          <a:ln w="936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flipH="1" flipV="1">
            <a:off x="599760" y="4384440"/>
            <a:ext cx="5784840" cy="4680"/>
          </a:xfrm>
          <a:prstGeom prst="line">
            <a:avLst/>
          </a:prstGeom>
          <a:ln w="936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405080" y="1660680"/>
            <a:ext cx="71280" cy="1440"/>
          </a:xfrm>
          <a:prstGeom prst="line">
            <a:avLst/>
          </a:prstGeom>
          <a:ln w="10800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H="1">
            <a:off x="2111400" y="1866960"/>
            <a:ext cx="171360" cy="1440"/>
          </a:xfrm>
          <a:prstGeom prst="line">
            <a:avLst/>
          </a:prstGeom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887400" y="1555920"/>
            <a:ext cx="168120" cy="1440"/>
          </a:xfrm>
          <a:prstGeom prst="line">
            <a:avLst/>
          </a:prstGeom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H="1">
            <a:off x="1305000" y="1549440"/>
            <a:ext cx="171360" cy="1440"/>
          </a:xfrm>
          <a:prstGeom prst="line">
            <a:avLst/>
          </a:prstGeom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880920" y="1612800"/>
            <a:ext cx="517680" cy="96840"/>
          </a:xfrm>
          <a:prstGeom prst="rect">
            <a:avLst/>
          </a:prstGeom>
          <a:solidFill>
            <a:srgbClr val="008000"/>
          </a:solidFill>
          <a:ln w="9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398600" y="1971720"/>
            <a:ext cx="71280" cy="1440"/>
          </a:xfrm>
          <a:prstGeom prst="line">
            <a:avLst/>
          </a:prstGeom>
          <a:ln w="10800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585720" y="2709720"/>
            <a:ext cx="39852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d5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211120" y="2982960"/>
            <a:ext cx="45936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ev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471680" y="3149640"/>
            <a:ext cx="806400" cy="96840"/>
          </a:xfrm>
          <a:prstGeom prst="rect">
            <a:avLst/>
          </a:prstGeom>
          <a:solidFill>
            <a:srgbClr val="ff6600"/>
          </a:solidFill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405080" y="2930400"/>
            <a:ext cx="71280" cy="1800"/>
          </a:xfrm>
          <a:prstGeom prst="line">
            <a:avLst/>
          </a:prstGeom>
          <a:ln w="10800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H="1">
            <a:off x="2111400" y="3092400"/>
            <a:ext cx="171360" cy="1800"/>
          </a:xfrm>
          <a:prstGeom prst="line">
            <a:avLst/>
          </a:prstGeom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887400" y="2825640"/>
            <a:ext cx="168120" cy="1800"/>
          </a:xfrm>
          <a:prstGeom prst="line">
            <a:avLst/>
          </a:prstGeom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880920" y="2882880"/>
            <a:ext cx="517680" cy="96840"/>
          </a:xfrm>
          <a:prstGeom prst="rect">
            <a:avLst/>
          </a:prstGeom>
          <a:solidFill>
            <a:srgbClr val="008000"/>
          </a:solidFill>
          <a:ln w="9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398600" y="3197160"/>
            <a:ext cx="71280" cy="1800"/>
          </a:xfrm>
          <a:prstGeom prst="line">
            <a:avLst/>
          </a:prstGeom>
          <a:ln w="10800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9" name=""/>
          <p:cNvGrpSpPr/>
          <p:nvPr/>
        </p:nvGrpSpPr>
        <p:grpSpPr>
          <a:xfrm>
            <a:off x="1397160" y="3003480"/>
            <a:ext cx="72720" cy="120600"/>
            <a:chOff x="1397160" y="3003480"/>
            <a:chExt cx="72720" cy="120600"/>
          </a:xfrm>
        </p:grpSpPr>
        <p:sp>
          <p:nvSpPr>
            <p:cNvPr id="90" name=""/>
            <p:cNvSpPr/>
            <p:nvPr/>
          </p:nvSpPr>
          <p:spPr>
            <a:xfrm flipH="1">
              <a:off x="1397160" y="3003480"/>
              <a:ext cx="72720" cy="12060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398600" y="3003480"/>
              <a:ext cx="69840" cy="12060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" name=""/>
          <p:cNvSpPr/>
          <p:nvPr/>
        </p:nvSpPr>
        <p:spPr>
          <a:xfrm>
            <a:off x="1422360" y="3427560"/>
            <a:ext cx="1800" cy="360360"/>
          </a:xfrm>
          <a:prstGeom prst="line">
            <a:avLst/>
          </a:prstGeom>
          <a:ln w="255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1471680" y="4216320"/>
            <a:ext cx="806400" cy="96840"/>
          </a:xfrm>
          <a:prstGeom prst="rect">
            <a:avLst/>
          </a:prstGeom>
          <a:solidFill>
            <a:srgbClr val="ff6600"/>
          </a:solidFill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880920" y="4216320"/>
            <a:ext cx="517680" cy="96840"/>
          </a:xfrm>
          <a:prstGeom prst="rect">
            <a:avLst/>
          </a:prstGeom>
          <a:solidFill>
            <a:srgbClr val="008000"/>
          </a:solidFill>
          <a:ln w="9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398600" y="4264200"/>
            <a:ext cx="71280" cy="1440"/>
          </a:xfrm>
          <a:prstGeom prst="line">
            <a:avLst/>
          </a:prstGeom>
          <a:ln w="10800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5051880" y="1087560"/>
            <a:ext cx="80100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SfiIM(9-18)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4230720" y="1096920"/>
            <a:ext cx="39852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d5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4469760" y="1414440"/>
            <a:ext cx="79488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SfiIM(9-18)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856120" y="1414440"/>
            <a:ext cx="45936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ev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5116680" y="1581120"/>
            <a:ext cx="806400" cy="96840"/>
          </a:xfrm>
          <a:prstGeom prst="rect">
            <a:avLst/>
          </a:prstGeom>
          <a:solidFill>
            <a:srgbClr val="ff6600"/>
          </a:solidFill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045040" y="1530360"/>
            <a:ext cx="168480" cy="1440"/>
          </a:xfrm>
          <a:prstGeom prst="line">
            <a:avLst/>
          </a:prstGeom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5049720" y="1317600"/>
            <a:ext cx="71640" cy="1440"/>
          </a:xfrm>
          <a:prstGeom prst="line">
            <a:avLst/>
          </a:prstGeom>
          <a:ln w="10800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flipH="1">
            <a:off x="5756400" y="1523880"/>
            <a:ext cx="171360" cy="1800"/>
          </a:xfrm>
          <a:prstGeom prst="line">
            <a:avLst/>
          </a:prstGeom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4532400" y="1212840"/>
            <a:ext cx="168120" cy="1440"/>
          </a:xfrm>
          <a:prstGeom prst="line">
            <a:avLst/>
          </a:prstGeom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flipH="1">
            <a:off x="4950000" y="1206360"/>
            <a:ext cx="171360" cy="1800"/>
          </a:xfrm>
          <a:prstGeom prst="line">
            <a:avLst/>
          </a:prstGeom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4525920" y="1270080"/>
            <a:ext cx="517680" cy="96840"/>
          </a:xfrm>
          <a:prstGeom prst="rect">
            <a:avLst/>
          </a:prstGeom>
          <a:solidFill>
            <a:srgbClr val="008000"/>
          </a:solidFill>
          <a:ln w="9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5043600" y="1628640"/>
            <a:ext cx="71280" cy="1800"/>
          </a:xfrm>
          <a:prstGeom prst="line">
            <a:avLst/>
          </a:prstGeom>
          <a:ln w="10800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351240" y="2038320"/>
            <a:ext cx="806400" cy="96840"/>
          </a:xfrm>
          <a:prstGeom prst="rect">
            <a:avLst/>
          </a:prstGeom>
          <a:solidFill>
            <a:srgbClr val="ff6600"/>
          </a:solidFill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849840" y="2733840"/>
            <a:ext cx="71280" cy="1440"/>
          </a:xfrm>
          <a:prstGeom prst="line">
            <a:avLst/>
          </a:prstGeom>
          <a:ln w="10800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849840" y="2946240"/>
            <a:ext cx="71280" cy="1800"/>
          </a:xfrm>
          <a:prstGeom prst="line">
            <a:avLst/>
          </a:prstGeom>
          <a:ln w="10800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855960" y="3162240"/>
            <a:ext cx="71640" cy="1800"/>
          </a:xfrm>
          <a:prstGeom prst="line">
            <a:avLst/>
          </a:prstGeom>
          <a:ln w="10152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3929040" y="4216320"/>
            <a:ext cx="806400" cy="96840"/>
          </a:xfrm>
          <a:prstGeom prst="rect">
            <a:avLst/>
          </a:prstGeom>
          <a:solidFill>
            <a:srgbClr val="ff6600"/>
          </a:solidFill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332160" y="4216320"/>
            <a:ext cx="517680" cy="96840"/>
          </a:xfrm>
          <a:prstGeom prst="rect">
            <a:avLst/>
          </a:prstGeom>
          <a:solidFill>
            <a:srgbClr val="008000"/>
          </a:solidFill>
          <a:ln w="9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3855960" y="4264200"/>
            <a:ext cx="71640" cy="1440"/>
          </a:xfrm>
          <a:prstGeom prst="line">
            <a:avLst/>
          </a:prstGeom>
          <a:ln w="10800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3892680" y="3427560"/>
            <a:ext cx="1440" cy="360360"/>
          </a:xfrm>
          <a:prstGeom prst="line">
            <a:avLst/>
          </a:prstGeom>
          <a:ln w="255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917720" y="4878360"/>
            <a:ext cx="758880" cy="96840"/>
          </a:xfrm>
          <a:prstGeom prst="rect">
            <a:avLst/>
          </a:prstGeom>
          <a:solidFill>
            <a:srgbClr val="ff6600"/>
          </a:solidFill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327320" y="4878360"/>
            <a:ext cx="517320" cy="96840"/>
          </a:xfrm>
          <a:prstGeom prst="rect">
            <a:avLst/>
          </a:prstGeom>
          <a:solidFill>
            <a:srgbClr val="008000"/>
          </a:solidFill>
          <a:ln w="9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844640" y="4927680"/>
            <a:ext cx="71640" cy="1440"/>
          </a:xfrm>
          <a:prstGeom prst="line">
            <a:avLst/>
          </a:prstGeom>
          <a:ln w="10800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363760" y="5072040"/>
            <a:ext cx="1074600" cy="196920"/>
          </a:xfrm>
          <a:prstGeom prst="rightArrow">
            <a:avLst>
              <a:gd name="adj1" fmla="val 50000"/>
              <a:gd name="adj2" fmla="val 136426"/>
            </a:avLst>
          </a:prstGeom>
          <a:solidFill>
            <a:srgbClr val="ff6600"/>
          </a:solidFill>
          <a:ln w="9360">
            <a:solidFill>
              <a:srgbClr val="ff6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3448080" y="5072040"/>
            <a:ext cx="71280" cy="1969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3366ff"/>
          </a:solidFill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532320" y="5072040"/>
            <a:ext cx="395280" cy="196920"/>
          </a:xfrm>
          <a:prstGeom prst="rightArrow">
            <a:avLst>
              <a:gd name="adj1" fmla="val 50000"/>
              <a:gd name="adj2" fmla="val 50183"/>
            </a:avLst>
          </a:prstGeom>
          <a:solidFill>
            <a:srgbClr val="660066"/>
          </a:solidFill>
          <a:ln w="9360">
            <a:solidFill>
              <a:srgbClr val="66006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3941640" y="5122800"/>
            <a:ext cx="193680" cy="96840"/>
          </a:xfrm>
          <a:prstGeom prst="rect">
            <a:avLst/>
          </a:prstGeom>
          <a:solidFill>
            <a:srgbClr val="008000"/>
          </a:solidFill>
          <a:ln w="9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1917720" y="5607000"/>
            <a:ext cx="1514520" cy="1047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1314360" y="6407280"/>
            <a:ext cx="517680" cy="96840"/>
          </a:xfrm>
          <a:prstGeom prst="rect">
            <a:avLst/>
          </a:prstGeom>
          <a:solidFill>
            <a:srgbClr val="008000"/>
          </a:solidFill>
          <a:ln w="9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1832040" y="6454800"/>
            <a:ext cx="71280" cy="1440"/>
          </a:xfrm>
          <a:prstGeom prst="line">
            <a:avLst/>
          </a:prstGeom>
          <a:ln w="10800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905120" y="6357960"/>
            <a:ext cx="1533240" cy="196920"/>
          </a:xfrm>
          <a:prstGeom prst="rightArrow">
            <a:avLst>
              <a:gd name="adj1" fmla="val 50000"/>
              <a:gd name="adj2" fmla="val 194653"/>
            </a:avLst>
          </a:prstGeom>
          <a:solidFill>
            <a:srgbClr val="ff6600"/>
          </a:solidFill>
          <a:ln w="9360">
            <a:solidFill>
              <a:srgbClr val="ff6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3448080" y="6357960"/>
            <a:ext cx="71280" cy="196920"/>
          </a:xfrm>
          <a:prstGeom prst="rightArrow">
            <a:avLst>
              <a:gd name="adj1" fmla="val 50000"/>
              <a:gd name="adj2" fmla="val 25000"/>
            </a:avLst>
          </a:prstGeom>
          <a:solidFill>
            <a:srgbClr val="3366ff"/>
          </a:solidFill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532320" y="6357960"/>
            <a:ext cx="395280" cy="196920"/>
          </a:xfrm>
          <a:prstGeom prst="rightArrow">
            <a:avLst>
              <a:gd name="adj1" fmla="val 50000"/>
              <a:gd name="adj2" fmla="val 50183"/>
            </a:avLst>
          </a:prstGeom>
          <a:solidFill>
            <a:srgbClr val="660066"/>
          </a:solidFill>
          <a:ln w="9360">
            <a:solidFill>
              <a:srgbClr val="66006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941640" y="6408720"/>
            <a:ext cx="193680" cy="96840"/>
          </a:xfrm>
          <a:prstGeom prst="rect">
            <a:avLst/>
          </a:prstGeom>
          <a:solidFill>
            <a:srgbClr val="008000"/>
          </a:solidFill>
          <a:ln w="9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 flipH="1">
            <a:off x="1382400" y="4978440"/>
            <a:ext cx="181080" cy="62712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1382760" y="4978440"/>
            <a:ext cx="177840" cy="62712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3995640" y="5222880"/>
            <a:ext cx="95400" cy="385920"/>
          </a:xfrm>
          <a:prstGeom prst="line">
            <a:avLst/>
          </a:prstGeom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3" name=""/>
          <p:cNvGrpSpPr/>
          <p:nvPr/>
        </p:nvGrpSpPr>
        <p:grpSpPr>
          <a:xfrm>
            <a:off x="2480760" y="4989600"/>
            <a:ext cx="73080" cy="120600"/>
            <a:chOff x="2480760" y="4989600"/>
            <a:chExt cx="73080" cy="120600"/>
          </a:xfrm>
        </p:grpSpPr>
        <p:sp>
          <p:nvSpPr>
            <p:cNvPr id="134" name=""/>
            <p:cNvSpPr/>
            <p:nvPr/>
          </p:nvSpPr>
          <p:spPr>
            <a:xfrm flipH="1">
              <a:off x="2480760" y="4989600"/>
              <a:ext cx="73080" cy="12060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2482920" y="4989600"/>
              <a:ext cx="69840" cy="12060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6" name=""/>
          <p:cNvSpPr/>
          <p:nvPr/>
        </p:nvSpPr>
        <p:spPr>
          <a:xfrm>
            <a:off x="2692440" y="5896080"/>
            <a:ext cx="1440" cy="360360"/>
          </a:xfrm>
          <a:prstGeom prst="line">
            <a:avLst/>
          </a:prstGeom>
          <a:ln w="255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3322800" y="2727360"/>
            <a:ext cx="525240" cy="1440"/>
          </a:xfrm>
          <a:prstGeom prst="line">
            <a:avLst/>
          </a:prstGeom>
          <a:ln w="101520">
            <a:solidFill>
              <a:srgbClr val="008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flipH="1">
            <a:off x="3917520" y="2727360"/>
            <a:ext cx="528840" cy="1440"/>
          </a:xfrm>
          <a:prstGeom prst="line">
            <a:avLst/>
          </a:prstGeom>
          <a:ln w="101520">
            <a:solidFill>
              <a:srgbClr val="008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3040200" y="2943360"/>
            <a:ext cx="807840" cy="1440"/>
          </a:xfrm>
          <a:prstGeom prst="line">
            <a:avLst/>
          </a:prstGeom>
          <a:ln w="101520">
            <a:solidFill>
              <a:srgbClr val="ff66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flipH="1">
            <a:off x="3919320" y="2943360"/>
            <a:ext cx="811080" cy="1440"/>
          </a:xfrm>
          <a:prstGeom prst="line">
            <a:avLst/>
          </a:prstGeom>
          <a:ln w="101520">
            <a:solidFill>
              <a:srgbClr val="ff66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3332160" y="3162240"/>
            <a:ext cx="525600" cy="1800"/>
          </a:xfrm>
          <a:prstGeom prst="line">
            <a:avLst/>
          </a:prstGeom>
          <a:ln w="101520">
            <a:solidFill>
              <a:srgbClr val="008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flipH="1">
            <a:off x="3922560" y="3162240"/>
            <a:ext cx="811440" cy="1800"/>
          </a:xfrm>
          <a:prstGeom prst="line">
            <a:avLst/>
          </a:prstGeom>
          <a:ln w="101520">
            <a:solidFill>
              <a:srgbClr val="ff66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flipV="1">
            <a:off x="1139760" y="1293480"/>
            <a:ext cx="54000" cy="3207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820800" y="1116000"/>
            <a:ext cx="51732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DR5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flipV="1">
            <a:off x="1990800" y="1560600"/>
            <a:ext cx="212760" cy="37152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2111760" y="1389240"/>
            <a:ext cx="57384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5’ CDR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2266920" y="5543640"/>
            <a:ext cx="90504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∆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DR5::HIS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flipH="1" flipV="1">
            <a:off x="887040" y="4061880"/>
            <a:ext cx="88920" cy="1558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780120" y="3878280"/>
            <a:ext cx="95796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5’ CDR1(1,2,4-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flipH="1" flipV="1">
            <a:off x="3325320" y="4061880"/>
            <a:ext cx="88920" cy="1558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3217680" y="3878280"/>
            <a:ext cx="84348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5’ CDR1(9-1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flipH="1" flipV="1">
            <a:off x="1318680" y="4722840"/>
            <a:ext cx="88920" cy="15552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1211400" y="4538520"/>
            <a:ext cx="101412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5’ CDR1(1,2,4-1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2803680" y="4722840"/>
            <a:ext cx="244440" cy="39672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965680" y="4538520"/>
            <a:ext cx="100800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’ CDR1 cassett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698920" y="5842080"/>
            <a:ext cx="3041640" cy="44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 transform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’ CDR1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nd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’ CDR1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cassette pai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 select for Ura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5435640" y="7416720"/>
            <a:ext cx="183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356760" y="8112240"/>
            <a:ext cx="284292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: 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